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9144000" cy="6858000" type="screen4x3"/>
  <p:notesSz cx="6669088" cy="9926638"/>
  <p:defaultTextStyle>
    <a:defPPr>
      <a:defRPr lang="nl-NL"/>
    </a:defPPr>
    <a:lvl1pPr algn="l" rtl="0" fontAlgn="base">
      <a:spcBef>
        <a:spcPct val="0"/>
      </a:spcBef>
      <a:spcAft>
        <a:spcPct val="0"/>
      </a:spcAft>
      <a:defRPr sz="1200" b="1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1200" b="1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1200" b="1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1200" b="1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1200" b="1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200" b="1"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sz="1200" b="1"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sz="1200" b="1"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sz="1200" b="1"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9173" autoAdjust="0"/>
  </p:normalViewPr>
  <p:slideViewPr>
    <p:cSldViewPr>
      <p:cViewPr>
        <p:scale>
          <a:sx n="100" d="100"/>
          <a:sy n="100" d="100"/>
        </p:scale>
        <p:origin x="-162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nl-NL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7B7E7F9-9F59-4876-8E4E-96CAF2A9CEDB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F5C4898-22C3-4936-8D00-5713DA228E9B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36FE27A-B417-4E14-B3EE-420CDD05925B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457200" y="274638"/>
            <a:ext cx="8229600" cy="585152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D4C748F-C9EF-4BB7-BD91-96BBBE1B49E0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E773870-BB5B-41C3-8387-8A10A3687A29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143A99C-833A-4FFD-A976-39238DDD619B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07A4346-4E8F-4FF1-AFF9-CD28EF7D4A74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80CC1D9-83C2-4F9C-BDD4-1154DFD05E66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3E4685-A34A-4815-979A-A0FBA4263AD5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6720663-D193-402F-B827-07408846A0B1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74C2AB-4DC0-4826-9248-C5D1B8A06F73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nl-NL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D86B968-1CE1-4331-9981-E2F63FE7DBBD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nl-NL" smtClean="0"/>
              <a:t>Klik om het opmaakprofiel te bewerk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nl-NL" smtClean="0"/>
              <a:t>Klik om de opmaakprofielen van de modeltekst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b="0"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b="0"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b="0"/>
            </a:lvl1pPr>
          </a:lstStyle>
          <a:p>
            <a:pPr>
              <a:defRPr/>
            </a:pPr>
            <a:fld id="{9304B479-0402-4996-8A11-E5625DCA36C0}" type="slidenum">
              <a:rPr lang="nl-NL"/>
              <a:pPr>
                <a:defRPr/>
              </a:pPr>
              <a:t>‹#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0" r:id="rId1"/>
    <p:sldLayoutId id="2147483659" r:id="rId2"/>
    <p:sldLayoutId id="2147483658" r:id="rId3"/>
    <p:sldLayoutId id="2147483657" r:id="rId4"/>
    <p:sldLayoutId id="2147483656" r:id="rId5"/>
    <p:sldLayoutId id="2147483655" r:id="rId6"/>
    <p:sldLayoutId id="2147483654" r:id="rId7"/>
    <p:sldLayoutId id="2147483653" r:id="rId8"/>
    <p:sldLayoutId id="2147483652" r:id="rId9"/>
    <p:sldLayoutId id="2147483651" r:id="rId10"/>
    <p:sldLayoutId id="2147483650" r:id="rId11"/>
    <p:sldLayoutId id="2147483649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09" name="Text Box 149"/>
          <p:cNvSpPr txBox="1">
            <a:spLocks noChangeArrowheads="1"/>
          </p:cNvSpPr>
          <p:nvPr/>
        </p:nvSpPr>
        <p:spPr bwMode="auto">
          <a:xfrm>
            <a:off x="0" y="0"/>
            <a:ext cx="297600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sz="1800" dirty="0" smtClean="0"/>
              <a:t>Additional file 2: Table S1</a:t>
            </a:r>
            <a:endParaRPr lang="nl-NL" sz="1800" dirty="0"/>
          </a:p>
        </p:txBody>
      </p:sp>
      <p:graphicFrame>
        <p:nvGraphicFramePr>
          <p:cNvPr id="37535" name="Group 1695"/>
          <p:cNvGraphicFramePr>
            <a:graphicFrameLocks noGrp="1"/>
          </p:cNvGraphicFramePr>
          <p:nvPr/>
        </p:nvGraphicFramePr>
        <p:xfrm>
          <a:off x="684213" y="1196975"/>
          <a:ext cx="5183187" cy="3667125"/>
        </p:xfrm>
        <a:graphic>
          <a:graphicData uri="http://schemas.openxmlformats.org/drawingml/2006/table">
            <a:tbl>
              <a:tblPr/>
              <a:tblGrid>
                <a:gridCol w="1698625"/>
                <a:gridCol w="604837"/>
                <a:gridCol w="576263"/>
                <a:gridCol w="576262"/>
                <a:gridCol w="576263"/>
                <a:gridCol w="576262"/>
                <a:gridCol w="574675"/>
              </a:tblGrid>
              <a:tr h="2444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1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2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3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4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5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6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44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Construct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44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Survivin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x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</a:rPr>
                        <a:t>x</a:t>
                      </a: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</a:rPr>
                        <a:t>x</a:t>
                      </a: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</a:rPr>
                        <a:t>x</a:t>
                      </a: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44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Ubi-Survivin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</a:rPr>
                        <a:t>x</a:t>
                      </a: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44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Mini-Survivin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</a:rPr>
                        <a:t>x</a:t>
                      </a: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</a:rPr>
                        <a:t>x</a:t>
                      </a: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44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Ubi-Mini-Survivin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0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</a:rPr>
                        <a:t>x</a:t>
                      </a:r>
                      <a:r>
                        <a:rPr kumimoji="0" lang="nl-NL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</a:rPr>
                        <a:t> </a:t>
                      </a:r>
                      <a:endParaRPr kumimoji="0" lang="nl-NL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cs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</a:rPr>
                        <a:t>x</a:t>
                      </a: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44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No. wells with 1*10</a:t>
                      </a:r>
                      <a:r>
                        <a:rPr kumimoji="0" lang="nl-NL" sz="1000" b="1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6</a:t>
                      </a:r>
                      <a:r>
                        <a:rPr kumimoji="0" lang="nl-NL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 cells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40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12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10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40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40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40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44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Priming APC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44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moDC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x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x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x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x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x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x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44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Restim. APC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44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moDC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x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x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x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x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44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JY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x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x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44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Readout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44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Tetramer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x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x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x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x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x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4475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ELIspot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x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x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x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cs typeface="Arial" charset="0"/>
                        </a:rPr>
                        <a:t> </a:t>
                      </a:r>
                      <a:endParaRPr kumimoji="0" lang="nl-NL" sz="12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</a:endParaRPr>
                    </a:p>
                  </a:txBody>
                  <a:tcPr anchor="b" horzOverflow="overflow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43140" name="Text Box 1649"/>
          <p:cNvSpPr txBox="1">
            <a:spLocks noChangeArrowheads="1"/>
          </p:cNvSpPr>
          <p:nvPr/>
        </p:nvSpPr>
        <p:spPr bwMode="auto">
          <a:xfrm>
            <a:off x="2354263" y="908050"/>
            <a:ext cx="633412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/>
              <a:t>Donor</a:t>
            </a:r>
          </a:p>
        </p:txBody>
      </p:sp>
      <p:sp>
        <p:nvSpPr>
          <p:cNvPr id="43141" name="Text Box 1696"/>
          <p:cNvSpPr txBox="1">
            <a:spLocks noChangeArrowheads="1"/>
          </p:cNvSpPr>
          <p:nvPr/>
        </p:nvSpPr>
        <p:spPr bwMode="auto">
          <a:xfrm>
            <a:off x="660400" y="4962525"/>
            <a:ext cx="424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nl-NL" b="0"/>
              <a:t>Note: IL12 was co-electroprated with the survivin constructs </a:t>
            </a:r>
          </a:p>
          <a:p>
            <a:r>
              <a:rPr lang="nl-NL" b="0"/>
              <a:t>accept in donors 2 and 3, where we co-electroporated IL21</a:t>
            </a:r>
          </a:p>
        </p:txBody>
      </p:sp>
      <p:sp>
        <p:nvSpPr>
          <p:cNvPr id="43142" name="Text Box 135"/>
          <p:cNvSpPr txBox="1">
            <a:spLocks noChangeArrowheads="1"/>
          </p:cNvSpPr>
          <p:nvPr/>
        </p:nvSpPr>
        <p:spPr bwMode="auto">
          <a:xfrm>
            <a:off x="6300788" y="1125538"/>
            <a:ext cx="2185987" cy="21236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dirty="0" smtClean="0"/>
              <a:t>Additional file 1:Table S1</a:t>
            </a:r>
            <a:endParaRPr lang="en-US" dirty="0"/>
          </a:p>
          <a:p>
            <a:r>
              <a:rPr lang="en-US" b="0" dirty="0"/>
              <a:t>Overview of </a:t>
            </a:r>
            <a:r>
              <a:rPr lang="en-US" b="0" dirty="0" err="1"/>
              <a:t>survivin</a:t>
            </a:r>
            <a:r>
              <a:rPr lang="en-US" b="0" dirty="0"/>
              <a:t> specific T cell inductions per donor. Shown are the mRNA constructs, the number of CD8+ T cells, the antigen presenting cell (for initial priming and subsequent </a:t>
            </a:r>
            <a:r>
              <a:rPr lang="en-US" b="0" dirty="0" err="1"/>
              <a:t>restimulation</a:t>
            </a:r>
            <a:r>
              <a:rPr lang="en-US" b="0" dirty="0"/>
              <a:t>), and the readout systems (tetramer and/or </a:t>
            </a:r>
            <a:r>
              <a:rPr lang="en-US" b="0" dirty="0" err="1"/>
              <a:t>ELIspot</a:t>
            </a:r>
            <a:r>
              <a:rPr lang="en-US" b="0" dirty="0"/>
              <a:t>) used.</a:t>
            </a:r>
            <a:endParaRPr lang="nl-NL" b="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tandaardontwerp">
  <a:themeElements>
    <a:clrScheme name="Standaardontwerp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ardontwerp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nl-NL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nl-NL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Standaardontwerp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ardontwerp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ardontwerp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ardontwerp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ardontwerp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ardontwerp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ardontwerp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ardontwerp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ardontwerp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ardontwerp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ardontwerp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ardontwerp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89</TotalTime>
  <Words>141</Words>
  <Application>Microsoft Office PowerPoint</Application>
  <PresentationFormat>On-screen Show (4:3)</PresentationFormat>
  <Paragraphs>1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Standaardontwerp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 1</dc:title>
  <dc:creator>A.Turksma</dc:creator>
  <cp:lastModifiedBy>Somoza, Jesun</cp:lastModifiedBy>
  <cp:revision>97</cp:revision>
  <dcterms:created xsi:type="dcterms:W3CDTF">2012-04-08T12:37:58Z</dcterms:created>
  <dcterms:modified xsi:type="dcterms:W3CDTF">2013-06-18T18:22:18Z</dcterms:modified>
</cp:coreProperties>
</file>